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9144000" type="letter"/>
  <p:notesSz cx="7077075" cy="9363075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988" autoAdjust="0"/>
    <p:restoredTop sz="94660"/>
  </p:normalViewPr>
  <p:slideViewPr>
    <p:cSldViewPr snapToGrid="0">
      <p:cViewPr>
        <p:scale>
          <a:sx n="120" d="100"/>
          <a:sy n="120" d="100"/>
        </p:scale>
        <p:origin x="350" y="-2381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6CA4C4-B264-4ECD-B56E-C9B90F55066E}" type="datetimeFigureOut">
              <a:rPr lang="en-US" smtClean="0"/>
              <a:t>1/10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F87F29-E0C7-4109-8B65-F6DC57479F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2423753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6CA4C4-B264-4ECD-B56E-C9B90F55066E}" type="datetimeFigureOut">
              <a:rPr lang="en-US" smtClean="0"/>
              <a:t>1/10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F87F29-E0C7-4109-8B65-F6DC57479F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8533658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6CA4C4-B264-4ECD-B56E-C9B90F55066E}" type="datetimeFigureOut">
              <a:rPr lang="en-US" smtClean="0"/>
              <a:t>1/10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F87F29-E0C7-4109-8B65-F6DC57479F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9539653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6CA4C4-B264-4ECD-B56E-C9B90F55066E}" type="datetimeFigureOut">
              <a:rPr lang="en-US" smtClean="0"/>
              <a:t>1/10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F87F29-E0C7-4109-8B65-F6DC57479F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1294271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6CA4C4-B264-4ECD-B56E-C9B90F55066E}" type="datetimeFigureOut">
              <a:rPr lang="en-US" smtClean="0"/>
              <a:t>1/10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F87F29-E0C7-4109-8B65-F6DC57479F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1887915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6CA4C4-B264-4ECD-B56E-C9B90F55066E}" type="datetimeFigureOut">
              <a:rPr lang="en-US" smtClean="0"/>
              <a:t>1/10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F87F29-E0C7-4109-8B65-F6DC57479F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923557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6CA4C4-B264-4ECD-B56E-C9B90F55066E}" type="datetimeFigureOut">
              <a:rPr lang="en-US" smtClean="0"/>
              <a:t>1/10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F87F29-E0C7-4109-8B65-F6DC57479F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0000538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6CA4C4-B264-4ECD-B56E-C9B90F55066E}" type="datetimeFigureOut">
              <a:rPr lang="en-US" smtClean="0"/>
              <a:t>1/10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F87F29-E0C7-4109-8B65-F6DC57479F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027969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6CA4C4-B264-4ECD-B56E-C9B90F55066E}" type="datetimeFigureOut">
              <a:rPr lang="en-US" smtClean="0"/>
              <a:t>1/10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F87F29-E0C7-4109-8B65-F6DC57479F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9828824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6CA4C4-B264-4ECD-B56E-C9B90F55066E}" type="datetimeFigureOut">
              <a:rPr lang="en-US" smtClean="0"/>
              <a:t>1/10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F87F29-E0C7-4109-8B65-F6DC57479F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295594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6CA4C4-B264-4ECD-B56E-C9B90F55066E}" type="datetimeFigureOut">
              <a:rPr lang="en-US" smtClean="0"/>
              <a:t>1/10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F87F29-E0C7-4109-8B65-F6DC57479F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9048384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E6CA4C4-B264-4ECD-B56E-C9B90F55066E}" type="datetimeFigureOut">
              <a:rPr lang="en-US" smtClean="0"/>
              <a:t>1/10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AF87F29-E0C7-4109-8B65-F6DC57479F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4424936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" name="Group 7">
            <a:extLst>
              <a:ext uri="{FF2B5EF4-FFF2-40B4-BE49-F238E27FC236}">
                <a16:creationId xmlns:a16="http://schemas.microsoft.com/office/drawing/2014/main" id="{5C98F3E7-FA70-62AB-31F8-C34E3FD336FA}"/>
              </a:ext>
            </a:extLst>
          </p:cNvPr>
          <p:cNvGrpSpPr/>
          <p:nvPr/>
        </p:nvGrpSpPr>
        <p:grpSpPr>
          <a:xfrm>
            <a:off x="116154" y="216406"/>
            <a:ext cx="6741846" cy="3318871"/>
            <a:chOff x="116154" y="216406"/>
            <a:chExt cx="6741846" cy="3318871"/>
          </a:xfrm>
        </p:grpSpPr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862F3EA2-ECC9-206E-E3F7-A377BB5D7D9B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16154" y="216406"/>
              <a:ext cx="3214760" cy="3072650"/>
            </a:xfrm>
            <a:prstGeom prst="rect">
              <a:avLst/>
            </a:prstGeom>
          </p:spPr>
        </p:pic>
        <p:pic>
          <p:nvPicPr>
            <p:cNvPr id="7" name="Picture 6">
              <a:extLst>
                <a:ext uri="{FF2B5EF4-FFF2-40B4-BE49-F238E27FC236}">
                  <a16:creationId xmlns:a16="http://schemas.microsoft.com/office/drawing/2014/main" id="{DA94A7C3-3C2B-79D0-A572-2CBCBAEE2109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3285315" y="243971"/>
              <a:ext cx="3572685" cy="3017520"/>
            </a:xfrm>
            <a:prstGeom prst="rect">
              <a:avLst/>
            </a:prstGeom>
          </p:spPr>
        </p:pic>
        <p:sp>
          <p:nvSpPr>
            <p:cNvPr id="2" name="TextBox 1">
              <a:extLst>
                <a:ext uri="{FF2B5EF4-FFF2-40B4-BE49-F238E27FC236}">
                  <a16:creationId xmlns:a16="http://schemas.microsoft.com/office/drawing/2014/main" id="{61B4D914-C961-1A69-D493-B35630B39D94}"/>
                </a:ext>
              </a:extLst>
            </p:cNvPr>
            <p:cNvSpPr txBox="1"/>
            <p:nvPr/>
          </p:nvSpPr>
          <p:spPr>
            <a:xfrm>
              <a:off x="1723534" y="3289056"/>
              <a:ext cx="132600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Biological Process</a:t>
              </a:r>
            </a:p>
          </p:txBody>
        </p:sp>
        <p:sp>
          <p:nvSpPr>
            <p:cNvPr id="3" name="TextBox 2">
              <a:extLst>
                <a:ext uri="{FF2B5EF4-FFF2-40B4-BE49-F238E27FC236}">
                  <a16:creationId xmlns:a16="http://schemas.microsoft.com/office/drawing/2014/main" id="{47E9E82A-74CB-5AD7-4FC9-3DBBDEF7EE3D}"/>
                </a:ext>
              </a:extLst>
            </p:cNvPr>
            <p:cNvSpPr txBox="1"/>
            <p:nvPr/>
          </p:nvSpPr>
          <p:spPr>
            <a:xfrm>
              <a:off x="5205874" y="3261491"/>
              <a:ext cx="135806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Molecular Function</a:t>
              </a:r>
            </a:p>
          </p:txBody>
        </p:sp>
      </p:grpSp>
      <p:sp>
        <p:nvSpPr>
          <p:cNvPr id="4" name="TextBox 3">
            <a:extLst>
              <a:ext uri="{FF2B5EF4-FFF2-40B4-BE49-F238E27FC236}">
                <a16:creationId xmlns:a16="http://schemas.microsoft.com/office/drawing/2014/main" id="{AE63AF96-8B0B-1930-400F-F5D632A957BE}"/>
              </a:ext>
            </a:extLst>
          </p:cNvPr>
          <p:cNvSpPr txBox="1"/>
          <p:nvPr/>
        </p:nvSpPr>
        <p:spPr>
          <a:xfrm>
            <a:off x="526071" y="6408860"/>
            <a:ext cx="5931877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2. 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ene Ontology enrichment analyses for biological process, molecular function, and cellular component of differentially expressed genes, combined over all timepoints, in reniform nematode resistant and susceptible roots.</a:t>
            </a:r>
          </a:p>
        </p:txBody>
      </p:sp>
      <p:pic>
        <p:nvPicPr>
          <p:cNvPr id="9" name="Picture 8">
            <a:extLst>
              <a:ext uri="{FF2B5EF4-FFF2-40B4-BE49-F238E27FC236}">
                <a16:creationId xmlns:a16="http://schemas.microsoft.com/office/drawing/2014/main" id="{CE1F6084-22F4-3D2E-15B3-9F2E6E0E5EED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979163" y="3697944"/>
            <a:ext cx="3025695" cy="2011680"/>
          </a:xfrm>
          <a:prstGeom prst="rect">
            <a:avLst/>
          </a:prstGeom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7BEB42B1-1327-5DC1-01BB-95290DF5BDAE}"/>
              </a:ext>
            </a:extLst>
          </p:cNvPr>
          <p:cNvSpPr txBox="1"/>
          <p:nvPr/>
        </p:nvSpPr>
        <p:spPr>
          <a:xfrm>
            <a:off x="3049538" y="5586513"/>
            <a:ext cx="144462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Cellular Component</a:t>
            </a:r>
          </a:p>
        </p:txBody>
      </p:sp>
    </p:spTree>
    <p:extLst>
      <p:ext uri="{BB962C8B-B14F-4D97-AF65-F5344CB8AC3E}">
        <p14:creationId xmlns:p14="http://schemas.microsoft.com/office/powerpoint/2010/main" val="137738492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126</TotalTime>
  <Words>42</Words>
  <Application>Microsoft Office PowerPoint</Application>
  <PresentationFormat>Letter Paper (8.5x11 in)</PresentationFormat>
  <Paragraphs>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Wubben, Martin - REE-ARS</dc:creator>
  <cp:lastModifiedBy>Wubben, Martin - REE-ARS</cp:lastModifiedBy>
  <cp:revision>7</cp:revision>
  <cp:lastPrinted>2024-03-07T20:17:26Z</cp:lastPrinted>
  <dcterms:created xsi:type="dcterms:W3CDTF">2023-10-23T13:53:27Z</dcterms:created>
  <dcterms:modified xsi:type="dcterms:W3CDTF">2025-01-10T19:33:06Z</dcterms:modified>
</cp:coreProperties>
</file>